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66" r:id="rId5"/>
    <p:sldId id="267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D60116F-FC02-0BA5-B897-58AD1D894BAA}" name="Mai Daido" initials="舞大" userId="S::mdaido@ncc.go.jp::9389fb6c-fc60-40a0-b40b-7a4c10271e3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59"/>
    <p:restoredTop sz="96327"/>
  </p:normalViewPr>
  <p:slideViewPr>
    <p:cSldViewPr snapToGrid="0" showGuides="1">
      <p:cViewPr varScale="1">
        <p:scale>
          <a:sx n="111" d="100"/>
          <a:sy n="111" d="100"/>
        </p:scale>
        <p:origin x="720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E6FA08-31B9-4C4F-8839-DA947C3A489C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F2C261-0D6C-9B46-B8C6-1132CF0BC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422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F2C261-0D6C-9B46-B8C6-1132CF0BC7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2226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1F2F06-8685-DB86-A527-2CFA3EF880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EF2C89A-6203-4A85-0EDC-9DED966576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599"/>
            </a:lvl4pPr>
            <a:lvl5pPr marL="1828726" indent="0" algn="ctr">
              <a:buNone/>
              <a:defRPr sz="1599"/>
            </a:lvl5pPr>
            <a:lvl6pPr marL="2285908" indent="0" algn="ctr">
              <a:buNone/>
              <a:defRPr sz="1599"/>
            </a:lvl6pPr>
            <a:lvl7pPr marL="2743090" indent="0" algn="ctr">
              <a:buNone/>
              <a:defRPr sz="1599"/>
            </a:lvl7pPr>
            <a:lvl8pPr marL="3200271" indent="0" algn="ctr">
              <a:buNone/>
              <a:defRPr sz="1599"/>
            </a:lvl8pPr>
            <a:lvl9pPr marL="3657453" indent="0" algn="ctr">
              <a:buNone/>
              <a:defRPr sz="1599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2798F-D532-7DC0-10F7-32A13AB5A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B0A9F9-6228-DCE6-19F9-1017FC813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E8E7D9-2322-6994-9AD6-2EDA9A18B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142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0ECA37-E5CD-9DCB-B9D1-46F79BABF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069D85-8EBC-FEAE-27DB-DD5A8ED04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9F5FF3-4087-DAFF-791E-C90804D41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FD7355-5E73-530E-D621-3DFAAE836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D80FFB-5F18-5F7F-E0A5-FD5CBF885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782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A19F20-9678-7FE6-2B39-A325E03488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C6A4AB-64C6-D498-80D3-0C0E2C91D2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EE0E07-732A-4C2F-D400-A31617C9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18925F-BECE-8D25-9B76-45E1CC429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C9C7EF-F011-0913-9F4C-DC4DA1875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673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5F30D5-BFEA-077F-5A45-C68D34039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70C4C1-613E-90D3-A03D-6BEA7E903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AEF59F-9A41-AD1E-3FE8-44963559B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94486A-4721-CBAB-96D6-B44029778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0B1BBE-F920-BC84-64BF-266B7CA55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455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7BFB84-AB03-BDDF-5FDF-00EC39CEE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2CDCF52-BEA5-6610-B86F-9504884054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4pPr>
            <a:lvl5pPr marL="1828726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5pPr>
            <a:lvl6pPr marL="2285908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7pPr>
            <a:lvl8pPr marL="3200271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8pPr>
            <a:lvl9pPr marL="365745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DECBB6-755F-A85B-D9D2-B1E05FA30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3480B0-96F7-9F30-98BD-7F04F1CED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FD4D1F-29A4-413C-61A5-589A84FEC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74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737927-9E9B-0920-0A16-75ACEF42E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840A3E-DB34-99E1-D862-9642AC359D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906F88-2EBF-0988-D96B-724C3E1931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43DDDE-F535-4DCA-2FAF-5BEE1A9C9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E39CD1-EA1B-C02E-BD2B-FA5988BFA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DEC4AC-6C5F-0F13-E547-D58A4C1B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583ECF-053F-9C4C-AEAF-5FB0E8283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F9B831-AD23-0BB9-ABEF-769040A3B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5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D29336-FCB2-9AA3-9881-E57DB15CF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29CBAA-FA2A-3AD3-9AC7-EAC2DF24E3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5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1FFED36-DB00-D174-84F6-3986A453A2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D77A53-3C7E-CEEE-2ECF-075EBAD27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842492-0B0A-05A0-ABF5-F80587047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C1A81BF-F346-CFFE-1758-28291018C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191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851A81-E021-76CA-7B5C-8064BC24E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5873BF-1891-1256-D025-71F8BB45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2091FF6-0E7B-51AA-81C8-78E89C383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A56ECE9-D9BE-EED0-510D-5351A2366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872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1DF71E-1FDF-FD58-B3CE-6AEB7070B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720EACF-230E-9C64-0E24-E781A78EC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1E101C-28C1-33B2-BF0A-A402FE7E9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239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BF99D9-3FB2-461D-DA3A-578F9939C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C17B60-617B-B04D-F0F0-73C8232CA7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>
              <a:defRPr sz="3201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6D6C29-2455-F85D-09BD-C4E57D654D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711FEE-A4B7-AB2F-130C-357CB4F51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F966CC-22CE-8F9F-A67F-0A99F19CD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6203D2-D03B-923F-7002-A296FFE38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850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653CDE-E17B-5878-AA0A-ADBB4C643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715F17F-29A4-60CB-0289-6312095FD0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 marL="0" indent="0">
              <a:buNone/>
              <a:defRPr sz="3201"/>
            </a:lvl1pPr>
            <a:lvl2pPr marL="457181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6" indent="0">
              <a:buNone/>
              <a:defRPr sz="2000"/>
            </a:lvl5pPr>
            <a:lvl6pPr marL="2285908" indent="0">
              <a:buNone/>
              <a:defRPr sz="2000"/>
            </a:lvl6pPr>
            <a:lvl7pPr marL="2743090" indent="0">
              <a:buNone/>
              <a:defRPr sz="2000"/>
            </a:lvl7pPr>
            <a:lvl8pPr marL="3200271" indent="0">
              <a:buNone/>
              <a:defRPr sz="2000"/>
            </a:lvl8pPr>
            <a:lvl9pPr marL="3657453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DA6F0A-28A1-8CED-2D6F-87611A04B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1D4CCB-310B-EC4A-ABB0-FD8F631D0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1E9EE70-CDAC-AF21-CCFE-2A0413137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CED987F-14FE-3FEF-388E-6414581D7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632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E1C4366-0060-CF40-8053-A2CCAC29E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0F2510-E9BF-3469-9799-50CA21438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5D482E-5F74-4F72-FE87-D3F7EBE7AC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94518A-775D-5D59-9292-C81EA902BF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6D7D29-4FF7-730F-F6A8-CF6406C619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759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kumimoji="1"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7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0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2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6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8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タイトル 1">
            <a:extLst>
              <a:ext uri="{FF2B5EF4-FFF2-40B4-BE49-F238E27FC236}">
                <a16:creationId xmlns:a16="http://schemas.microsoft.com/office/drawing/2014/main" id="{75D97E26-D4F0-02AB-C1DA-8A66F13E52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667014" y="240015"/>
            <a:ext cx="3376302" cy="349468"/>
          </a:xfrm>
        </p:spPr>
        <p:txBody>
          <a:bodyPr anchor="ctr">
            <a:no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9708AE5-7039-FD84-802E-E1A1E0B08E07}"/>
              </a:ext>
            </a:extLst>
          </p:cNvPr>
          <p:cNvSpPr txBox="1"/>
          <p:nvPr/>
        </p:nvSpPr>
        <p:spPr>
          <a:xfrm>
            <a:off x="211285" y="8561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A2B35A7-D1DC-1FB1-9409-D9362076E1BD}"/>
              </a:ext>
            </a:extLst>
          </p:cNvPr>
          <p:cNvSpPr txBox="1"/>
          <p:nvPr/>
        </p:nvSpPr>
        <p:spPr>
          <a:xfrm>
            <a:off x="6106391" y="84580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FF4C7567-51D3-1161-7DAD-0B736004EAE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06" t="24000" r="8783" b="19018"/>
          <a:stretch/>
        </p:blipFill>
        <p:spPr>
          <a:xfrm>
            <a:off x="46742" y="1482644"/>
            <a:ext cx="6059649" cy="4100362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991DB06E-3D1C-6D7D-F294-C06A35FF321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288" t="24280" r="8081" b="19017"/>
          <a:stretch/>
        </p:blipFill>
        <p:spPr>
          <a:xfrm>
            <a:off x="6045946" y="1482644"/>
            <a:ext cx="6120093" cy="41003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35935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8269829-263E-1E02-2310-804E81413721}"/>
              </a:ext>
            </a:extLst>
          </p:cNvPr>
          <p:cNvSpPr txBox="1"/>
          <p:nvPr/>
        </p:nvSpPr>
        <p:spPr>
          <a:xfrm>
            <a:off x="854015" y="319177"/>
            <a:ext cx="1035169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3.</a:t>
            </a:r>
            <a:r>
              <a:rPr lang="en-US" sz="1800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sz="18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Subgroup analyses of overall survival. (A) Gefitinib cohort. (B) Osimertinib cohort. </a:t>
            </a:r>
            <a:r>
              <a:rPr lang="en-US" sz="1800" kern="10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Abbreviations: CI, confidence interval; EGFR, epidermal growth factor receptor; Ex19del, EGFR exon 19 deletion; L858R, EGFR exon 21 L858 point mutation; ECOG, Eastern Clinical Oncology group; PS, performance status; EGFR-TKI, epidermal growth factor receptor tyrosine kinase inhibitor; CNS, central nervous system.</a:t>
            </a:r>
            <a:endParaRPr lang="en-US" sz="1800" kern="100">
              <a:effectLst/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957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JCOG1404_figure_20230610SK" id="{DB95F260-CF21-1748-AC8B-AD4DDBE68E9F}" vid="{83143335-8646-B546-855E-BB91D15FA112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73cef40-5c85-4c4a-b41b-9378f7da5d40" xsi:nil="true"/>
    <lcf76f155ced4ddcb4097134ff3c332f xmlns="a2d3df0c-b642-49de-aebc-0bdfbd4fcb12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8DFAD2F25B8E48B7434BEA17FFE1EF" ma:contentTypeVersion="12" ma:contentTypeDescription="Create a new document." ma:contentTypeScope="" ma:versionID="282010726508f5d26b8368cad674d9b3">
  <xsd:schema xmlns:xsd="http://www.w3.org/2001/XMLSchema" xmlns:xs="http://www.w3.org/2001/XMLSchema" xmlns:p="http://schemas.microsoft.com/office/2006/metadata/properties" xmlns:ns2="a2d3df0c-b642-49de-aebc-0bdfbd4fcb12" xmlns:ns3="473cef40-5c85-4c4a-b41b-9378f7da5d40" targetNamespace="http://schemas.microsoft.com/office/2006/metadata/properties" ma:root="true" ma:fieldsID="2dd7d420d565b4772615de0368552ab2" ns2:_="" ns3:_="">
    <xsd:import namespace="a2d3df0c-b642-49de-aebc-0bdfbd4fcb12"/>
    <xsd:import namespace="473cef40-5c85-4c4a-b41b-9378f7da5d4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d3df0c-b642-49de-aebc-0bdfbd4fcb1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3cef40-5c85-4c4a-b41b-9378f7da5d4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a30e90b5-2565-4993-a569-1b992df32115}" ma:internalName="TaxCatchAll" ma:showField="CatchAllData" ma:web="473cef40-5c85-4c4a-b41b-9378f7da5d4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063B294-D9A3-4239-9434-AED526C50F2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67B9D4E-D646-4A90-B6FC-7417C7D6B0D1}">
  <ds:schemaRefs>
    <ds:schemaRef ds:uri="http://schemas.microsoft.com/office/2006/metadata/properties"/>
    <ds:schemaRef ds:uri="http://schemas.microsoft.com/office/infopath/2007/PartnerControls"/>
    <ds:schemaRef ds:uri="473cef40-5c85-4c4a-b41b-9378f7da5d40"/>
    <ds:schemaRef ds:uri="a2d3df0c-b642-49de-aebc-0bdfbd4fcb12"/>
  </ds:schemaRefs>
</ds:datastoreItem>
</file>

<file path=customXml/itemProps3.xml><?xml version="1.0" encoding="utf-8"?>
<ds:datastoreItem xmlns:ds="http://schemas.openxmlformats.org/officeDocument/2006/customXml" ds:itemID="{14BDCB13-D2BC-47AA-8671-2884A56396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d3df0c-b642-49de-aebc-0bdfbd4fcb12"/>
    <ds:schemaRef ds:uri="473cef40-5c85-4c4a-b41b-9378f7da5d4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022</TotalTime>
  <Words>86</Words>
  <Application>Microsoft Office PowerPoint</Application>
  <PresentationFormat>Widescreen</PresentationFormat>
  <Paragraphs>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Yu Mincho</vt:lpstr>
      <vt:lpstr>Arial</vt:lpstr>
      <vt:lpstr>Office テーマ</vt:lpstr>
      <vt:lpstr>Supplementary Figure S3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. Study hypothesis</dc:title>
  <dc:subject/>
  <dc:creator>神田　慎太郎</dc:creator>
  <cp:keywords/>
  <dc:description/>
  <cp:lastModifiedBy>Opio, Arlene</cp:lastModifiedBy>
  <cp:revision>65</cp:revision>
  <dcterms:created xsi:type="dcterms:W3CDTF">2023-08-19T05:43:47Z</dcterms:created>
  <dcterms:modified xsi:type="dcterms:W3CDTF">2025-03-21T19:27:13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8DFAD2F25B8E48B7434BEA17FFE1EF</vt:lpwstr>
  </property>
</Properties>
</file>